
<file path=[Content_Types].xml><?xml version="1.0" encoding="utf-8"?>
<Types xmlns="http://schemas.openxmlformats.org/package/2006/content-types"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letter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612" autoAdjust="0"/>
    <p:restoredTop sz="94660"/>
  </p:normalViewPr>
  <p:slideViewPr>
    <p:cSldViewPr>
      <p:cViewPr varScale="1">
        <p:scale>
          <a:sx n="62" d="100"/>
          <a:sy n="62" d="100"/>
        </p:scale>
        <p:origin x="2448" y="53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732606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7431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672523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454425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31108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627909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83309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0721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39306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983374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23624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09230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wmf"/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wmf"/><Relationship Id="rId4" Type="http://schemas.openxmlformats.org/officeDocument/2006/relationships/image" Target="../media/image3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feld 25"/>
          <p:cNvSpPr txBox="1"/>
          <p:nvPr/>
        </p:nvSpPr>
        <p:spPr>
          <a:xfrm>
            <a:off x="522042" y="1109597"/>
            <a:ext cx="323165" cy="115212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Overall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(%)</a:t>
            </a:r>
          </a:p>
        </p:txBody>
      </p:sp>
      <p:sp>
        <p:nvSpPr>
          <p:cNvPr id="29" name="Textfeld 28"/>
          <p:cNvSpPr txBox="1"/>
          <p:nvPr/>
        </p:nvSpPr>
        <p:spPr>
          <a:xfrm>
            <a:off x="858398" y="2966175"/>
            <a:ext cx="58109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 49          36           26          12           6            3                                         31           21           11            5             3</a:t>
            </a:r>
          </a:p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 16            9             2            1           0            0                                         12             3             0            0             0</a:t>
            </a:r>
          </a:p>
        </p:txBody>
      </p:sp>
      <p:sp>
        <p:nvSpPr>
          <p:cNvPr id="30" name="Textfeld 29"/>
          <p:cNvSpPr txBox="1"/>
          <p:nvPr/>
        </p:nvSpPr>
        <p:spPr>
          <a:xfrm>
            <a:off x="-63948" y="2843808"/>
            <a:ext cx="9481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at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risk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≤ 25%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increase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&gt; 25%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increase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548680" y="179512"/>
            <a:ext cx="2448272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  LDH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LDH ≤ULN in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pembrolizumab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set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3789040" y="179512"/>
            <a:ext cx="288032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LDH change in patients with baseline </a:t>
            </a:r>
            <a:b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LDH &gt;ULN in the pembrolizumab set</a:t>
            </a:r>
            <a:endParaRPr lang="de-DE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feld 43"/>
          <p:cNvSpPr txBox="1"/>
          <p:nvPr/>
        </p:nvSpPr>
        <p:spPr>
          <a:xfrm>
            <a:off x="3789040" y="1110138"/>
            <a:ext cx="323165" cy="115212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Overall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(%)</a:t>
            </a:r>
          </a:p>
        </p:txBody>
      </p:sp>
      <p:sp>
        <p:nvSpPr>
          <p:cNvPr id="45" name="Textfeld 44"/>
          <p:cNvSpPr txBox="1"/>
          <p:nvPr/>
        </p:nvSpPr>
        <p:spPr>
          <a:xfrm>
            <a:off x="870030" y="2722652"/>
            <a:ext cx="24353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Time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ince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tart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immunotherapy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6" name="Textfeld 45"/>
          <p:cNvSpPr txBox="1"/>
          <p:nvPr/>
        </p:nvSpPr>
        <p:spPr>
          <a:xfrm>
            <a:off x="4128672" y="2722652"/>
            <a:ext cx="24353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Time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ince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tart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immunotherapy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D8F3D2AE-0694-4FA0-A339-A15ACAF7F77F}"/>
              </a:ext>
            </a:extLst>
          </p:cNvPr>
          <p:cNvSpPr txBox="1"/>
          <p:nvPr/>
        </p:nvSpPr>
        <p:spPr>
          <a:xfrm>
            <a:off x="3200937" y="2843808"/>
            <a:ext cx="9481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at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risk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≤ 25%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increase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&gt; 25%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increase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8846B99A-87BB-4E2D-B6AD-D8CD8DA22A2C}"/>
              </a:ext>
            </a:extLst>
          </p:cNvPr>
          <p:cNvSpPr txBox="1"/>
          <p:nvPr/>
        </p:nvSpPr>
        <p:spPr>
          <a:xfrm>
            <a:off x="522042" y="4464356"/>
            <a:ext cx="323165" cy="115212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Overall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(%)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F16807E4-9D07-45CE-9EB8-1CEAE51AA379}"/>
              </a:ext>
            </a:extLst>
          </p:cNvPr>
          <p:cNvSpPr txBox="1"/>
          <p:nvPr/>
        </p:nvSpPr>
        <p:spPr>
          <a:xfrm>
            <a:off x="858398" y="6320934"/>
            <a:ext cx="58109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 22        22        15         6          2          1         0                                        25        20       15       13        8         5         1</a:t>
            </a:r>
          </a:p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 17        15        11         7          1          1         1                                        11          6         5         2        1         1         1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1E424DD2-058C-4076-A871-FF36A4664E27}"/>
              </a:ext>
            </a:extLst>
          </p:cNvPr>
          <p:cNvSpPr txBox="1"/>
          <p:nvPr/>
        </p:nvSpPr>
        <p:spPr>
          <a:xfrm>
            <a:off x="-63948" y="6198567"/>
            <a:ext cx="9481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at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risk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≤ 25%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increase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&gt; 25%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increase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A7380FAA-F5FF-4544-818C-B1D490BFE48A}"/>
              </a:ext>
            </a:extLst>
          </p:cNvPr>
          <p:cNvSpPr txBox="1"/>
          <p:nvPr/>
        </p:nvSpPr>
        <p:spPr>
          <a:xfrm>
            <a:off x="548679" y="3534271"/>
            <a:ext cx="3049739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LDH change in patients with baseline </a:t>
            </a:r>
            <a:b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LDH ≤ULN in the 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pilimumab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+ 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nivolumab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set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F136958C-278D-4650-9BD4-62139D5D90B7}"/>
              </a:ext>
            </a:extLst>
          </p:cNvPr>
          <p:cNvSpPr txBox="1"/>
          <p:nvPr/>
        </p:nvSpPr>
        <p:spPr>
          <a:xfrm>
            <a:off x="3789039" y="3534271"/>
            <a:ext cx="2880321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LDH change in patients with baseline </a:t>
            </a:r>
            <a:b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LDH &gt;ULN in the 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pilimumab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+ 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nivolumab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set</a:t>
            </a:r>
            <a:endParaRPr lang="de-DE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641C1947-BB9C-444B-8D5D-C2225D55EF32}"/>
              </a:ext>
            </a:extLst>
          </p:cNvPr>
          <p:cNvSpPr txBox="1"/>
          <p:nvPr/>
        </p:nvSpPr>
        <p:spPr>
          <a:xfrm>
            <a:off x="3789040" y="4464897"/>
            <a:ext cx="323165" cy="115212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Overall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(%)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F6FA7562-7D68-489E-A1B4-A4AC984A0FC5}"/>
              </a:ext>
            </a:extLst>
          </p:cNvPr>
          <p:cNvSpPr txBox="1"/>
          <p:nvPr/>
        </p:nvSpPr>
        <p:spPr>
          <a:xfrm>
            <a:off x="870030" y="6077411"/>
            <a:ext cx="24353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Time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ince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tart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immunotherapy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A68BBEF5-BD41-4F3B-851D-C45F8B1A9643}"/>
              </a:ext>
            </a:extLst>
          </p:cNvPr>
          <p:cNvSpPr txBox="1"/>
          <p:nvPr/>
        </p:nvSpPr>
        <p:spPr>
          <a:xfrm>
            <a:off x="4128672" y="6077411"/>
            <a:ext cx="24353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Time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ince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tart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immunotherapy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4C4D6D7E-CF7C-4A9E-8C98-138CAC89C66F}"/>
              </a:ext>
            </a:extLst>
          </p:cNvPr>
          <p:cNvSpPr txBox="1"/>
          <p:nvPr/>
        </p:nvSpPr>
        <p:spPr>
          <a:xfrm>
            <a:off x="3200937" y="6198567"/>
            <a:ext cx="9481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at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risk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≤ 25%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increase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&gt; 25%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increase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1B0FA777-1CAD-4979-8FEF-29539C60F8D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020" r="22973" b="26022"/>
          <a:stretch/>
        </p:blipFill>
        <p:spPr>
          <a:xfrm>
            <a:off x="754637" y="582293"/>
            <a:ext cx="2520000" cy="2190321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3A9C39D0-3F44-4EE4-A17D-E8B103C9673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545" r="23554" b="26022"/>
          <a:stretch/>
        </p:blipFill>
        <p:spPr>
          <a:xfrm>
            <a:off x="4012761" y="600692"/>
            <a:ext cx="2520000" cy="2189662"/>
          </a:xfrm>
          <a:prstGeom prst="rect">
            <a:avLst/>
          </a:prstGeom>
        </p:spPr>
      </p:pic>
      <p:sp>
        <p:nvSpPr>
          <p:cNvPr id="2" name="Textfeld 1">
            <a:extLst>
              <a:ext uri="{FF2B5EF4-FFF2-40B4-BE49-F238E27FC236}">
                <a16:creationId xmlns:a16="http://schemas.microsoft.com/office/drawing/2014/main" id="{CD2DBF36-3923-423A-80F1-33EE25B872F8}"/>
              </a:ext>
            </a:extLst>
          </p:cNvPr>
          <p:cNvSpPr txBox="1"/>
          <p:nvPr/>
        </p:nvSpPr>
        <p:spPr>
          <a:xfrm>
            <a:off x="522041" y="7236296"/>
            <a:ext cx="600743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.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Overall survival according to early changes in LDH grouped by baseline LDH. Abbreviations: HR, hazard ratio; LDH, lactate dehydrogenase; 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-value.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6F0B8AE7-B677-4584-B4D7-431BE3348E7F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020" r="21901" b="26022"/>
          <a:stretch/>
        </p:blipFill>
        <p:spPr>
          <a:xfrm>
            <a:off x="754637" y="3960296"/>
            <a:ext cx="2520000" cy="2160248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43D987E9-B8DB-4EB6-9640-7D93EF643163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545" r="21901" b="26022"/>
          <a:stretch/>
        </p:blipFill>
        <p:spPr>
          <a:xfrm>
            <a:off x="4023347" y="3969641"/>
            <a:ext cx="2520000" cy="21433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9450925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0</Words>
  <Application>Microsoft Office PowerPoint</Application>
  <PresentationFormat>Letter (8,5x11 Zoll)</PresentationFormat>
  <Paragraphs>2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Nikolaus Wagner</dc:creator>
  <cp:lastModifiedBy>Nikolaus</cp:lastModifiedBy>
  <cp:revision>34</cp:revision>
  <dcterms:created xsi:type="dcterms:W3CDTF">2015-02-26T10:00:16Z</dcterms:created>
  <dcterms:modified xsi:type="dcterms:W3CDTF">2018-05-15T21:35:24Z</dcterms:modified>
</cp:coreProperties>
</file>